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8" d="100"/>
          <a:sy n="108" d="100"/>
        </p:scale>
        <p:origin x="-108" y="-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5622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6114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2520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2276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1499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36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5641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062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6068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4344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6616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2A2A6C-B7EE-4D8D-B545-7459D6F13E91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FA324-AB0B-48B0-BF81-B3E0F130E4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581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5560" y="188641"/>
            <a:ext cx="6264696" cy="3024337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2063552" y="3356993"/>
            <a:ext cx="64087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  Overview of quality of deep sequencing</a:t>
            </a:r>
            <a:endParaRPr lang="en-SG" sz="1400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1895831" y="3933056"/>
          <a:ext cx="8229601" cy="1295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867193"/>
                <a:gridCol w="1955353"/>
                <a:gridCol w="2128175"/>
                <a:gridCol w="1278880"/>
              </a:tblGrid>
              <a:tr h="3238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 smtClean="0">
                          <a:effectLst/>
                        </a:rPr>
                        <a:t>Tissue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 smtClean="0">
                          <a:effectLst/>
                        </a:rPr>
                        <a:t>Read </a:t>
                      </a:r>
                      <a:r>
                        <a:rPr lang="en-US" sz="1600" kern="1200" dirty="0">
                          <a:effectLst/>
                        </a:rPr>
                        <a:t>size (</a:t>
                      </a:r>
                      <a:r>
                        <a:rPr lang="en-US" sz="1600" kern="1200" dirty="0" err="1">
                          <a:effectLst/>
                        </a:rPr>
                        <a:t>bp</a:t>
                      </a:r>
                      <a:r>
                        <a:rPr lang="en-US" sz="1600" kern="1200" dirty="0">
                          <a:effectLst/>
                        </a:rPr>
                        <a:t>) 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 smtClean="0">
                          <a:effectLst/>
                        </a:rPr>
                        <a:t>Raw </a:t>
                      </a:r>
                      <a:r>
                        <a:rPr lang="en-US" sz="1600" kern="1200" dirty="0">
                          <a:effectLst/>
                        </a:rPr>
                        <a:t>reads  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 smtClean="0">
                          <a:effectLst/>
                        </a:rPr>
                        <a:t>Pair </a:t>
                      </a:r>
                      <a:r>
                        <a:rPr lang="en-US" sz="1600" kern="1200" dirty="0">
                          <a:effectLst/>
                        </a:rPr>
                        <a:t>end 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238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 smtClean="0">
                          <a:effectLst/>
                        </a:rPr>
                        <a:t>PGT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101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115,191,961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yes 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238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Leaf </a:t>
                      </a:r>
                      <a:r>
                        <a:rPr lang="en-US" sz="1600" kern="1200" dirty="0" smtClean="0">
                          <a:effectLst/>
                        </a:rPr>
                        <a:t>–PGT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101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136,558,099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>
                          <a:effectLst/>
                        </a:rPr>
                        <a:t>yes </a:t>
                      </a:r>
                      <a:endParaRPr lang="en-SG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3238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leaf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101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115,404,986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1200" dirty="0">
                          <a:effectLst/>
                        </a:rPr>
                        <a:t>yes </a:t>
                      </a:r>
                      <a:endParaRPr lang="en-SG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7" name="Rectangle 1"/>
          <p:cNvSpPr>
            <a:spLocks noChangeArrowheads="1"/>
          </p:cNvSpPr>
          <p:nvPr/>
        </p:nvSpPr>
        <p:spPr bwMode="auto">
          <a:xfrm>
            <a:off x="2135561" y="5301208"/>
            <a:ext cx="229800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400" dirty="0">
                <a:latin typeface="Calibri" pitchFamily="34" charset="0"/>
                <a:ea typeface="SimSun" pitchFamily="2" charset="-122"/>
                <a:cs typeface="Times New Roman" pitchFamily="18" charset="0"/>
              </a:rPr>
              <a:t>Statistics of deep sequencing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zh-CN" sz="1400" dirty="0"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919536" y="5925300"/>
            <a:ext cx="1481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dditional </a:t>
            </a:r>
            <a:r>
              <a:rPr lang="en-US" sz="1400" b="1"/>
              <a:t>File </a:t>
            </a:r>
            <a:r>
              <a:rPr lang="en-US" sz="1400" b="1" smtClean="0"/>
              <a:t>2</a:t>
            </a:r>
            <a:r>
              <a:rPr lang="en-US" sz="1400" smtClean="0"/>
              <a:t> </a:t>
            </a:r>
            <a:endParaRPr lang="en-SG" sz="1400" dirty="0"/>
          </a:p>
        </p:txBody>
      </p:sp>
    </p:spTree>
    <p:extLst>
      <p:ext uri="{BB962C8B-B14F-4D97-AF65-F5344CB8AC3E}">
        <p14:creationId xmlns:p14="http://schemas.microsoft.com/office/powerpoint/2010/main" val="706590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金静静</dc:creator>
  <cp:lastModifiedBy>Sarojam Rajani</cp:lastModifiedBy>
  <cp:revision>3</cp:revision>
  <dcterms:created xsi:type="dcterms:W3CDTF">2014-05-23T09:39:53Z</dcterms:created>
  <dcterms:modified xsi:type="dcterms:W3CDTF">2014-05-26T07:48:07Z</dcterms:modified>
</cp:coreProperties>
</file>